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 snapToGrid="0">
      <p:cViewPr>
        <p:scale>
          <a:sx n="90" d="100"/>
          <a:sy n="90" d="100"/>
        </p:scale>
        <p:origin x="167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luwatoyin Tella" userId="a70e8c4191ea61f2" providerId="LiveId" clId="{32422DB8-F743-40F0-893A-EDA0226A5610}"/>
    <pc:docChg chg="undo custSel modSld">
      <pc:chgData name="Oluwatoyin Tella" userId="a70e8c4191ea61f2" providerId="LiveId" clId="{32422DB8-F743-40F0-893A-EDA0226A5610}" dt="2023-10-22T21:09:14.834" v="92" actId="207"/>
      <pc:docMkLst>
        <pc:docMk/>
      </pc:docMkLst>
      <pc:sldChg chg="modSp mod">
        <pc:chgData name="Oluwatoyin Tella" userId="a70e8c4191ea61f2" providerId="LiveId" clId="{32422DB8-F743-40F0-893A-EDA0226A5610}" dt="2023-10-22T21:09:14.834" v="92" actId="207"/>
        <pc:sldMkLst>
          <pc:docMk/>
          <pc:sldMk cId="2353236782" sldId="256"/>
        </pc:sldMkLst>
        <pc:spChg chg="mod">
          <ac:chgData name="Oluwatoyin Tella" userId="a70e8c4191ea61f2" providerId="LiveId" clId="{32422DB8-F743-40F0-893A-EDA0226A5610}" dt="2023-10-22T21:07:32.436" v="70" actId="6549"/>
          <ac:spMkLst>
            <pc:docMk/>
            <pc:sldMk cId="2353236782" sldId="256"/>
            <ac:spMk id="12" creationId="{E356B2E3-99BA-78C3-8334-4DEAE6BC79B6}"/>
          </ac:spMkLst>
        </pc:spChg>
        <pc:spChg chg="mod">
          <ac:chgData name="Oluwatoyin Tella" userId="a70e8c4191ea61f2" providerId="LiveId" clId="{32422DB8-F743-40F0-893A-EDA0226A5610}" dt="2023-10-22T21:07:41.860" v="72" actId="6549"/>
          <ac:spMkLst>
            <pc:docMk/>
            <pc:sldMk cId="2353236782" sldId="256"/>
            <ac:spMk id="13" creationId="{810D5755-5DFC-4974-89F0-A2ADE0C44713}"/>
          </ac:spMkLst>
        </pc:spChg>
        <pc:spChg chg="mod">
          <ac:chgData name="Oluwatoyin Tella" userId="a70e8c4191ea61f2" providerId="LiveId" clId="{32422DB8-F743-40F0-893A-EDA0226A5610}" dt="2023-10-22T21:07:48.777" v="78" actId="6549"/>
          <ac:spMkLst>
            <pc:docMk/>
            <pc:sldMk cId="2353236782" sldId="256"/>
            <ac:spMk id="15" creationId="{67456A14-16D2-2802-7006-022D98372DE5}"/>
          </ac:spMkLst>
        </pc:spChg>
        <pc:spChg chg="mod">
          <ac:chgData name="Oluwatoyin Tella" userId="a70e8c4191ea61f2" providerId="LiveId" clId="{32422DB8-F743-40F0-893A-EDA0226A5610}" dt="2023-10-22T21:07:46.231" v="76" actId="6549"/>
          <ac:spMkLst>
            <pc:docMk/>
            <pc:sldMk cId="2353236782" sldId="256"/>
            <ac:spMk id="16" creationId="{135CB9E1-2E03-AD9B-8DE9-4E73890989D1}"/>
          </ac:spMkLst>
        </pc:spChg>
        <pc:spChg chg="mod">
          <ac:chgData name="Oluwatoyin Tella" userId="a70e8c4191ea61f2" providerId="LiveId" clId="{32422DB8-F743-40F0-893A-EDA0226A5610}" dt="2023-10-22T21:09:14.834" v="92" actId="207"/>
          <ac:spMkLst>
            <pc:docMk/>
            <pc:sldMk cId="2353236782" sldId="256"/>
            <ac:spMk id="17" creationId="{AF20E465-3043-66C8-CA96-ADD234749F44}"/>
          </ac:spMkLst>
        </pc:spChg>
        <pc:spChg chg="mod">
          <ac:chgData name="Oluwatoyin Tella" userId="a70e8c4191ea61f2" providerId="LiveId" clId="{32422DB8-F743-40F0-893A-EDA0226A5610}" dt="2023-10-22T21:09:09.307" v="91" actId="207"/>
          <ac:spMkLst>
            <pc:docMk/>
            <pc:sldMk cId="2353236782" sldId="256"/>
            <ac:spMk id="18" creationId="{D73F76F7-15B4-B586-C250-195311A3F1C8}"/>
          </ac:spMkLst>
        </pc:spChg>
        <pc:spChg chg="mod">
          <ac:chgData name="Oluwatoyin Tella" userId="a70e8c4191ea61f2" providerId="LiveId" clId="{32422DB8-F743-40F0-893A-EDA0226A5610}" dt="2023-10-22T21:07:08.095" v="68" actId="6549"/>
          <ac:spMkLst>
            <pc:docMk/>
            <pc:sldMk cId="2353236782" sldId="256"/>
            <ac:spMk id="25" creationId="{1444B8B0-B742-BB48-CE57-C80D69FD5501}"/>
          </ac:spMkLst>
        </pc:spChg>
        <pc:spChg chg="mod">
          <ac:chgData name="Oluwatoyin Tella" userId="a70e8c4191ea61f2" providerId="LiveId" clId="{32422DB8-F743-40F0-893A-EDA0226A5610}" dt="2023-10-22T21:04:27.744" v="19" actId="207"/>
          <ac:spMkLst>
            <pc:docMk/>
            <pc:sldMk cId="2353236782" sldId="256"/>
            <ac:spMk id="30" creationId="{B3796C28-396A-D004-0A64-5CBC58B2AEA6}"/>
          </ac:spMkLst>
        </pc:spChg>
        <pc:spChg chg="mod">
          <ac:chgData name="Oluwatoyin Tella" userId="a70e8c4191ea61f2" providerId="LiveId" clId="{32422DB8-F743-40F0-893A-EDA0226A5610}" dt="2023-10-22T21:05:32.223" v="33" actId="14100"/>
          <ac:spMkLst>
            <pc:docMk/>
            <pc:sldMk cId="2353236782" sldId="256"/>
            <ac:spMk id="37" creationId="{401208DF-7177-8CEB-F8CB-1F18965D1ED5}"/>
          </ac:spMkLst>
        </pc:spChg>
        <pc:spChg chg="mod">
          <ac:chgData name="Oluwatoyin Tella" userId="a70e8c4191ea61f2" providerId="LiveId" clId="{32422DB8-F743-40F0-893A-EDA0226A5610}" dt="2023-10-22T21:07:01.706" v="66" actId="6549"/>
          <ac:spMkLst>
            <pc:docMk/>
            <pc:sldMk cId="2353236782" sldId="256"/>
            <ac:spMk id="38" creationId="{5685F94E-A09D-AF2E-7002-48D6455C16BC}"/>
          </ac:spMkLst>
        </pc:spChg>
        <pc:cxnChg chg="mod">
          <ac:chgData name="Oluwatoyin Tella" userId="a70e8c4191ea61f2" providerId="LiveId" clId="{32422DB8-F743-40F0-893A-EDA0226A5610}" dt="2023-10-22T21:05:32.223" v="33" actId="14100"/>
          <ac:cxnSpMkLst>
            <pc:docMk/>
            <pc:sldMk cId="2353236782" sldId="256"/>
            <ac:cxnSpMk id="49" creationId="{B2A007F1-0FAD-E920-3085-E18F7300C0B9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0215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373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577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6942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6419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135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027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5181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779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121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927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3326A5-A70E-0D4C-8246-1AA13DF91EFD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23565-AB65-AB40-A923-C272C4E6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7870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6431699-2609-07CA-2060-43351D4A76FF}"/>
              </a:ext>
            </a:extLst>
          </p:cNvPr>
          <p:cNvSpPr txBox="1"/>
          <p:nvPr/>
        </p:nvSpPr>
        <p:spPr>
          <a:xfrm>
            <a:off x="4020690" y="1782740"/>
            <a:ext cx="3856574" cy="4205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altLang="ja-JP" sz="2133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ORT 2010 Flow Diagram</a:t>
            </a:r>
            <a:r>
              <a:rPr lang="ja-JP" altLang="ja-JP" sz="2133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2133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角丸四角形 7">
            <a:extLst>
              <a:ext uri="{FF2B5EF4-FFF2-40B4-BE49-F238E27FC236}">
                <a16:creationId xmlns:a16="http://schemas.microsoft.com/office/drawing/2014/main" id="{7DA66EE9-1199-23B0-03A3-95F932A86F88}"/>
              </a:ext>
            </a:extLst>
          </p:cNvPr>
          <p:cNvSpPr/>
          <p:nvPr/>
        </p:nvSpPr>
        <p:spPr>
          <a:xfrm>
            <a:off x="5047359" y="6488698"/>
            <a:ext cx="2060027" cy="6621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rollment</a:t>
            </a:r>
            <a:endParaRPr lang="ja-JP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角丸四角形 8">
            <a:extLst>
              <a:ext uri="{FF2B5EF4-FFF2-40B4-BE49-F238E27FC236}">
                <a16:creationId xmlns:a16="http://schemas.microsoft.com/office/drawing/2014/main" id="{FE14FF70-B53A-9D5C-A4CA-54EF56422A39}"/>
              </a:ext>
            </a:extLst>
          </p:cNvPr>
          <p:cNvSpPr/>
          <p:nvPr/>
        </p:nvSpPr>
        <p:spPr>
          <a:xfrm>
            <a:off x="5047358" y="8965818"/>
            <a:ext cx="2060027" cy="6621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location</a:t>
            </a:r>
            <a:endParaRPr lang="ja-JP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角丸四角形 9">
            <a:extLst>
              <a:ext uri="{FF2B5EF4-FFF2-40B4-BE49-F238E27FC236}">
                <a16:creationId xmlns:a16="http://schemas.microsoft.com/office/drawing/2014/main" id="{1368C0CD-DF9B-7BDA-6B69-9052C38FD78F}"/>
              </a:ext>
            </a:extLst>
          </p:cNvPr>
          <p:cNvSpPr/>
          <p:nvPr/>
        </p:nvSpPr>
        <p:spPr>
          <a:xfrm>
            <a:off x="5047357" y="12392502"/>
            <a:ext cx="2060027" cy="6621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endParaRPr lang="ja-JP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角丸四角形 10">
            <a:extLst>
              <a:ext uri="{FF2B5EF4-FFF2-40B4-BE49-F238E27FC236}">
                <a16:creationId xmlns:a16="http://schemas.microsoft.com/office/drawing/2014/main" id="{3325FB60-4522-2639-7913-88F97318B601}"/>
              </a:ext>
            </a:extLst>
          </p:cNvPr>
          <p:cNvSpPr/>
          <p:nvPr/>
        </p:nvSpPr>
        <p:spPr>
          <a:xfrm>
            <a:off x="5065949" y="10677269"/>
            <a:ext cx="2060027" cy="662153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-up</a:t>
            </a:r>
            <a:endParaRPr lang="ja-JP" altLang="en-US" sz="1801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E356B2E3-99BA-78C3-8334-4DEAE6BC79B6}"/>
              </a:ext>
            </a:extLst>
          </p:cNvPr>
          <p:cNvSpPr/>
          <p:nvPr/>
        </p:nvSpPr>
        <p:spPr>
          <a:xfrm>
            <a:off x="219001" y="8722191"/>
            <a:ext cx="4642311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vention (n=7)</a:t>
            </a:r>
          </a:p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d hand grip strength training</a:t>
            </a:r>
            <a:endParaRPr lang="ja-JP" altLang="en-US" sz="1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810D5755-5DFC-4974-89F0-A2ADE0C44713}"/>
              </a:ext>
            </a:extLst>
          </p:cNvPr>
          <p:cNvSpPr/>
          <p:nvPr/>
        </p:nvSpPr>
        <p:spPr>
          <a:xfrm>
            <a:off x="7330613" y="8722191"/>
            <a:ext cx="4642386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 (n=6)</a:t>
            </a:r>
          </a:p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d standard care</a:t>
            </a:r>
            <a:endParaRPr lang="ja-JP" altLang="en-US" sz="1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67456A14-16D2-2802-7006-022D98372DE5}"/>
              </a:ext>
            </a:extLst>
          </p:cNvPr>
          <p:cNvSpPr/>
          <p:nvPr/>
        </p:nvSpPr>
        <p:spPr>
          <a:xfrm>
            <a:off x="7330613" y="10437424"/>
            <a:ext cx="4642386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t to follow-up (n=1)</a:t>
            </a:r>
          </a:p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e patient withdrew his consent.</a:t>
            </a: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135CB9E1-2E03-AD9B-8DE9-4E73890989D1}"/>
              </a:ext>
            </a:extLst>
          </p:cNvPr>
          <p:cNvSpPr/>
          <p:nvPr/>
        </p:nvSpPr>
        <p:spPr>
          <a:xfrm>
            <a:off x="219001" y="10437424"/>
            <a:ext cx="4642311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st to follow-up (n=0)</a:t>
            </a:r>
          </a:p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continued intervention (n=0)</a:t>
            </a:r>
            <a:endParaRPr lang="ja-JP" altLang="en-US" sz="1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AF20E465-3043-66C8-CA96-ADD234749F44}"/>
              </a:ext>
            </a:extLst>
          </p:cNvPr>
          <p:cNvSpPr/>
          <p:nvPr/>
        </p:nvSpPr>
        <p:spPr>
          <a:xfrm>
            <a:off x="219001" y="12152657"/>
            <a:ext cx="4642386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zed (n=5)</a:t>
            </a:r>
          </a:p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wo patients were excluded from the analysis</a:t>
            </a:r>
          </a:p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due to a consciousness disorder</a:t>
            </a:r>
            <a:r>
              <a:rPr lang="ja-JP" altLang="ja-JP" sz="1801" dirty="0">
                <a:solidFill>
                  <a:schemeClr val="tx1"/>
                </a:solidFill>
              </a:rPr>
              <a:t> </a:t>
            </a:r>
            <a:endParaRPr lang="ja-JP" altLang="en-US" sz="18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D73F76F7-15B4-B586-C250-195311A3F1C8}"/>
              </a:ext>
            </a:extLst>
          </p:cNvPr>
          <p:cNvSpPr/>
          <p:nvPr/>
        </p:nvSpPr>
        <p:spPr>
          <a:xfrm>
            <a:off x="7330613" y="12188746"/>
            <a:ext cx="4642386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zed (n=4)</a:t>
            </a:r>
          </a:p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e patient was excluded from the analysis</a:t>
            </a:r>
          </a:p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due to a consciousness disorder</a:t>
            </a:r>
            <a:r>
              <a:rPr lang="ja-JP" altLang="ja-JP" sz="1801" dirty="0">
                <a:solidFill>
                  <a:schemeClr val="tx1"/>
                </a:solidFill>
              </a:rPr>
              <a:t> </a:t>
            </a:r>
            <a:endParaRPr lang="ja-JP" altLang="en-US" sz="18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7EE95F04-61A5-5002-D146-334ECE15AB86}"/>
              </a:ext>
            </a:extLst>
          </p:cNvPr>
          <p:cNvCxnSpPr>
            <a:cxnSpLocks/>
            <a:endCxn id="13" idx="0"/>
          </p:cNvCxnSpPr>
          <p:nvPr/>
        </p:nvCxnSpPr>
        <p:spPr>
          <a:xfrm flipH="1">
            <a:off x="9651806" y="7923430"/>
            <a:ext cx="7847" cy="79876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F153951F-97EB-BDC9-62BF-7F259DA03568}"/>
              </a:ext>
            </a:extLst>
          </p:cNvPr>
          <p:cNvCxnSpPr>
            <a:cxnSpLocks/>
            <a:stCxn id="25" idx="2"/>
            <a:endCxn id="12" idx="0"/>
          </p:cNvCxnSpPr>
          <p:nvPr/>
        </p:nvCxnSpPr>
        <p:spPr>
          <a:xfrm>
            <a:off x="2540149" y="7150316"/>
            <a:ext cx="8" cy="1571875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1138193F-D456-58C0-49E6-8BC48DF3E1D6}"/>
              </a:ext>
            </a:extLst>
          </p:cNvPr>
          <p:cNvCxnSpPr>
            <a:cxnSpLocks/>
          </p:cNvCxnSpPr>
          <p:nvPr/>
        </p:nvCxnSpPr>
        <p:spPr>
          <a:xfrm>
            <a:off x="2537725" y="7937398"/>
            <a:ext cx="713683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5688BDB6-04C6-96CC-B252-F81874322495}"/>
              </a:ext>
            </a:extLst>
          </p:cNvPr>
          <p:cNvCxnSpPr>
            <a:cxnSpLocks/>
            <a:stCxn id="12" idx="2"/>
            <a:endCxn id="16" idx="0"/>
          </p:cNvCxnSpPr>
          <p:nvPr/>
        </p:nvCxnSpPr>
        <p:spPr>
          <a:xfrm>
            <a:off x="2540157" y="9864035"/>
            <a:ext cx="0" cy="57338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線矢印コネクタ 42">
            <a:extLst>
              <a:ext uri="{FF2B5EF4-FFF2-40B4-BE49-F238E27FC236}">
                <a16:creationId xmlns:a16="http://schemas.microsoft.com/office/drawing/2014/main" id="{435D6DFB-3607-9FA7-570C-2D7C70527EF1}"/>
              </a:ext>
            </a:extLst>
          </p:cNvPr>
          <p:cNvCxnSpPr>
            <a:cxnSpLocks/>
            <a:stCxn id="13" idx="2"/>
            <a:endCxn id="15" idx="0"/>
          </p:cNvCxnSpPr>
          <p:nvPr/>
        </p:nvCxnSpPr>
        <p:spPr>
          <a:xfrm>
            <a:off x="9651806" y="9864035"/>
            <a:ext cx="0" cy="57338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8D4029C0-E0DC-8B7F-09DC-8DE12854B178}"/>
              </a:ext>
            </a:extLst>
          </p:cNvPr>
          <p:cNvCxnSpPr>
            <a:cxnSpLocks/>
            <a:stCxn id="15" idx="2"/>
            <a:endCxn id="18" idx="0"/>
          </p:cNvCxnSpPr>
          <p:nvPr/>
        </p:nvCxnSpPr>
        <p:spPr>
          <a:xfrm>
            <a:off x="9651806" y="11579268"/>
            <a:ext cx="0" cy="609478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1444B8B0-B742-BB48-CE57-C80D69FD5501}"/>
              </a:ext>
            </a:extLst>
          </p:cNvPr>
          <p:cNvSpPr/>
          <p:nvPr/>
        </p:nvSpPr>
        <p:spPr>
          <a:xfrm>
            <a:off x="219001" y="6008472"/>
            <a:ext cx="4642295" cy="114184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 patients included in this study</a:t>
            </a:r>
          </a:p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ndomized (n=13)</a:t>
            </a:r>
            <a:endParaRPr lang="ja-JP" altLang="en-US" sz="1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71C529CD-C074-597D-7113-D3BA0661B815}"/>
              </a:ext>
            </a:extLst>
          </p:cNvPr>
          <p:cNvSpPr/>
          <p:nvPr/>
        </p:nvSpPr>
        <p:spPr>
          <a:xfrm>
            <a:off x="296689" y="2963002"/>
            <a:ext cx="6955826" cy="39567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total of 125 patients underwent elective cardiac surgery </a:t>
            </a:r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&gt;60 years)</a:t>
            </a:r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401208DF-7177-8CEB-F8CB-1F18965D1ED5}"/>
              </a:ext>
            </a:extLst>
          </p:cNvPr>
          <p:cNvSpPr/>
          <p:nvPr/>
        </p:nvSpPr>
        <p:spPr>
          <a:xfrm>
            <a:off x="3265867" y="3740365"/>
            <a:ext cx="8821358" cy="39567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3 patients with </a:t>
            </a:r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preoperative handgrip strength of &gt;30 </a:t>
            </a:r>
            <a:r>
              <a:rPr lang="en-US" altLang="ja-JP" sz="1801" dirty="0" err="1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kgf</a:t>
            </a:r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 for males and &gt; 20 </a:t>
            </a:r>
            <a:r>
              <a:rPr lang="en-US" altLang="ja-JP" sz="1801" dirty="0" err="1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kgf</a:t>
            </a:r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ea typeface="HG丸ｺﾞｼｯｸM-PRO" panose="020F0600000000000000" pitchFamily="34" charset="-128"/>
              </a:rPr>
              <a:t> for females</a:t>
            </a:r>
            <a:r>
              <a:rPr lang="ja-JP" altLang="ja-JP" sz="1801" dirty="0">
                <a:solidFill>
                  <a:schemeClr val="tx1"/>
                </a:solidFill>
              </a:rPr>
              <a:t> </a:t>
            </a:r>
            <a:endParaRPr lang="ja-JP" altLang="en-US" sz="18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5685F94E-A09D-AF2E-7002-48D6455C16BC}"/>
              </a:ext>
            </a:extLst>
          </p:cNvPr>
          <p:cNvSpPr/>
          <p:nvPr/>
        </p:nvSpPr>
        <p:spPr>
          <a:xfrm>
            <a:off x="296689" y="4631294"/>
            <a:ext cx="5017571" cy="3956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 total of 42 patients were recruited in this study</a:t>
            </a:r>
            <a:endParaRPr lang="ja-JP" altLang="en-US" sz="180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B8858DC1-4019-CE18-F28E-91815E681BE9}"/>
              </a:ext>
            </a:extLst>
          </p:cNvPr>
          <p:cNvSpPr/>
          <p:nvPr/>
        </p:nvSpPr>
        <p:spPr>
          <a:xfrm>
            <a:off x="3240466" y="5330470"/>
            <a:ext cx="4028980" cy="39567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ja-JP" sz="180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9 patients did not consent to this study</a:t>
            </a:r>
            <a:endParaRPr lang="ja-JP" altLang="en-US" sz="1801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1911A11C-7929-A92E-7CB1-C6F74C79167F}"/>
              </a:ext>
            </a:extLst>
          </p:cNvPr>
          <p:cNvCxnSpPr>
            <a:cxnSpLocks/>
          </p:cNvCxnSpPr>
          <p:nvPr/>
        </p:nvCxnSpPr>
        <p:spPr>
          <a:xfrm>
            <a:off x="2540252" y="5025994"/>
            <a:ext cx="46" cy="1004625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864597C8-00A9-9018-E791-C352686E5608}"/>
              </a:ext>
            </a:extLst>
          </p:cNvPr>
          <p:cNvCxnSpPr>
            <a:cxnSpLocks/>
          </p:cNvCxnSpPr>
          <p:nvPr/>
        </p:nvCxnSpPr>
        <p:spPr>
          <a:xfrm>
            <a:off x="2540149" y="3358675"/>
            <a:ext cx="0" cy="12641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B2A007F1-0FAD-E920-3085-E18F7300C0B9}"/>
              </a:ext>
            </a:extLst>
          </p:cNvPr>
          <p:cNvCxnSpPr>
            <a:cxnSpLocks/>
            <a:endCxn id="37" idx="1"/>
          </p:cNvCxnSpPr>
          <p:nvPr/>
        </p:nvCxnSpPr>
        <p:spPr>
          <a:xfrm flipV="1">
            <a:off x="2542652" y="3938201"/>
            <a:ext cx="723215" cy="513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90CA8C81-652E-A22A-4646-A3DABE0B23E6}"/>
              </a:ext>
            </a:extLst>
          </p:cNvPr>
          <p:cNvCxnSpPr>
            <a:cxnSpLocks/>
          </p:cNvCxnSpPr>
          <p:nvPr/>
        </p:nvCxnSpPr>
        <p:spPr>
          <a:xfrm>
            <a:off x="2537725" y="5516948"/>
            <a:ext cx="702741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256125E3-412F-038A-9934-676D01078AD9}"/>
              </a:ext>
            </a:extLst>
          </p:cNvPr>
          <p:cNvCxnSpPr>
            <a:cxnSpLocks/>
            <a:stCxn id="16" idx="2"/>
            <a:endCxn id="17" idx="0"/>
          </p:cNvCxnSpPr>
          <p:nvPr/>
        </p:nvCxnSpPr>
        <p:spPr>
          <a:xfrm>
            <a:off x="2540157" y="11579268"/>
            <a:ext cx="37" cy="573389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3236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5</TotalTime>
  <Words>154</Words>
  <Application>Microsoft Macintosh PowerPoint</Application>
  <PresentationFormat>ユーザー設定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甲谷 太一</dc:creator>
  <cp:lastModifiedBy>甲谷 太一</cp:lastModifiedBy>
  <cp:revision>15</cp:revision>
  <dcterms:created xsi:type="dcterms:W3CDTF">2023-10-06T10:12:55Z</dcterms:created>
  <dcterms:modified xsi:type="dcterms:W3CDTF">2023-11-09T05:24:04Z</dcterms:modified>
</cp:coreProperties>
</file>